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5"/>
  </p:notesMasterIdLst>
  <p:sldIdLst>
    <p:sldId id="263" r:id="rId2"/>
    <p:sldId id="264" r:id="rId3"/>
    <p:sldId id="265" r:id="rId4"/>
  </p:sldIdLst>
  <p:sldSz cx="6858000" cy="9906000" type="A4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howGuides="1">
      <p:cViewPr varScale="1">
        <p:scale>
          <a:sx n="53" d="100"/>
          <a:sy n="53" d="100"/>
        </p:scale>
        <p:origin x="1356" y="84"/>
      </p:cViewPr>
      <p:guideLst>
        <p:guide orient="horz" pos="5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4982770-1BDF-4226-9C58-4FB8BFFA17FD}" type="datetimeFigureOut">
              <a:rPr lang="ko-KR" altLang="en-US" smtClean="0"/>
              <a:t>2019-08-01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9E6837B-8565-409C-82E1-4CD6A17DC40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3736730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9E6837B-8565-409C-82E1-4CD6A17DC407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9385830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9E6837B-8565-409C-82E1-4CD6A17DC407}" type="slidenum">
              <a:rPr lang="ko-KR" altLang="en-US" smtClean="0"/>
              <a:t>2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0525205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9E6837B-8565-409C-82E1-4CD6A17DC407}" type="slidenum">
              <a:rPr lang="ko-KR" altLang="en-US" smtClean="0"/>
              <a:t>3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1017180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 smtClean="0"/>
              <a:t>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B0D4EC-20C2-40CA-A6F8-799E83A2E0FB}" type="datetimeFigureOut">
              <a:rPr lang="ko-KR" altLang="en-US" smtClean="0"/>
              <a:t>2019-08-0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2EA9A3-D739-412A-8C1E-33EE18BD3DA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935486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B0D4EC-20C2-40CA-A6F8-799E83A2E0FB}" type="datetimeFigureOut">
              <a:rPr lang="ko-KR" altLang="en-US" smtClean="0"/>
              <a:t>2019-08-0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2EA9A3-D739-412A-8C1E-33EE18BD3DA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880456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B0D4EC-20C2-40CA-A6F8-799E83A2E0FB}" type="datetimeFigureOut">
              <a:rPr lang="ko-KR" altLang="en-US" smtClean="0"/>
              <a:t>2019-08-0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2EA9A3-D739-412A-8C1E-33EE18BD3DA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299923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B0D4EC-20C2-40CA-A6F8-799E83A2E0FB}" type="datetimeFigureOut">
              <a:rPr lang="ko-KR" altLang="en-US" smtClean="0"/>
              <a:t>2019-08-0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2EA9A3-D739-412A-8C1E-33EE18BD3DA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00854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B0D4EC-20C2-40CA-A6F8-799E83A2E0FB}" type="datetimeFigureOut">
              <a:rPr lang="ko-KR" altLang="en-US" smtClean="0"/>
              <a:t>2019-08-0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2EA9A3-D739-412A-8C1E-33EE18BD3DA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382119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B0D4EC-20C2-40CA-A6F8-799E83A2E0FB}" type="datetimeFigureOut">
              <a:rPr lang="ko-KR" altLang="en-US" smtClean="0"/>
              <a:t>2019-08-0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2EA9A3-D739-412A-8C1E-33EE18BD3DA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700314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B0D4EC-20C2-40CA-A6F8-799E83A2E0FB}" type="datetimeFigureOut">
              <a:rPr lang="ko-KR" altLang="en-US" smtClean="0"/>
              <a:t>2019-08-01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2EA9A3-D739-412A-8C1E-33EE18BD3DA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322227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B0D4EC-20C2-40CA-A6F8-799E83A2E0FB}" type="datetimeFigureOut">
              <a:rPr lang="ko-KR" altLang="en-US" smtClean="0"/>
              <a:t>2019-08-01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2EA9A3-D739-412A-8C1E-33EE18BD3DA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49430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B0D4EC-20C2-40CA-A6F8-799E83A2E0FB}" type="datetimeFigureOut">
              <a:rPr lang="ko-KR" altLang="en-US" smtClean="0"/>
              <a:t>2019-08-01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2EA9A3-D739-412A-8C1E-33EE18BD3DA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131251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B0D4EC-20C2-40CA-A6F8-799E83A2E0FB}" type="datetimeFigureOut">
              <a:rPr lang="ko-KR" altLang="en-US" smtClean="0"/>
              <a:t>2019-08-0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2EA9A3-D739-412A-8C1E-33EE18BD3DA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092666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B0D4EC-20C2-40CA-A6F8-799E83A2E0FB}" type="datetimeFigureOut">
              <a:rPr lang="ko-KR" altLang="en-US" smtClean="0"/>
              <a:t>2019-08-0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2EA9A3-D739-412A-8C1E-33EE18BD3DA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188782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B0D4EC-20C2-40CA-A6F8-799E83A2E0FB}" type="datetimeFigureOut">
              <a:rPr lang="ko-KR" altLang="en-US" smtClean="0"/>
              <a:t>2019-08-0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2EA9A3-D739-412A-8C1E-33EE18BD3DA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144374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/>
          <p:cNvSpPr txBox="1"/>
          <p:nvPr/>
        </p:nvSpPr>
        <p:spPr>
          <a:xfrm>
            <a:off x="4365105" y="0"/>
            <a:ext cx="2504306" cy="3002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351" b="1" dirty="0" smtClean="0">
                <a:latin typeface="Arial" panose="020B0604020202020204" pitchFamily="34" charset="0"/>
                <a:cs typeface="Arial" panose="020B0604020202020204" pitchFamily="34" charset="0"/>
              </a:rPr>
              <a:t> Supplementary Table 2</a:t>
            </a:r>
            <a:endParaRPr lang="ko-KR" altLang="en-US" sz="135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" name="표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90041417"/>
              </p:ext>
            </p:extLst>
          </p:nvPr>
        </p:nvGraphicFramePr>
        <p:xfrm>
          <a:off x="471487" y="416496"/>
          <a:ext cx="5915025" cy="3201890"/>
        </p:xfrm>
        <a:graphic>
          <a:graphicData uri="http://schemas.openxmlformats.org/drawingml/2006/table">
            <a:tbl>
              <a:tblPr/>
              <a:tblGrid>
                <a:gridCol w="167209"/>
                <a:gridCol w="815144"/>
                <a:gridCol w="644950"/>
                <a:gridCol w="2615630"/>
                <a:gridCol w="836046"/>
                <a:gridCol w="836046"/>
              </a:tblGrid>
              <a:tr h="190595"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ccession No.</a:t>
                      </a: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Gene Name</a:t>
                      </a: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rotein Description</a:t>
                      </a: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Fold Change</a:t>
                      </a: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-Log</a:t>
                      </a:r>
                      <a:r>
                        <a:rPr lang="en-GB" sz="800" b="1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0</a:t>
                      </a:r>
                      <a:r>
                        <a:rPr lang="en-GB" sz="8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(</a:t>
                      </a:r>
                      <a:r>
                        <a:rPr lang="en-GB" sz="800" b="1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</a:t>
                      </a:r>
                      <a:r>
                        <a:rPr lang="en-GB" sz="8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-value</a:t>
                      </a:r>
                      <a:r>
                        <a:rPr lang="en-GB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)</a:t>
                      </a: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</a:tr>
              <a:tr h="143395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3395">
                <a:tc gridSpan="3">
                  <a:txBody>
                    <a:bodyPr/>
                    <a:lstStyle/>
                    <a:p>
                      <a:pPr algn="l" fontAlgn="ctr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Up-regulated proteins (1D)</a:t>
                      </a: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3395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61014</a:t>
                      </a: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ln</a:t>
                      </a: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Cardiac phospholamban</a:t>
                      </a: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534 </a:t>
                      </a: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281 </a:t>
                      </a: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3395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Q3TCU5</a:t>
                      </a: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Tapbp</a:t>
                      </a: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Tapasin</a:t>
                      </a: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965 </a:t>
                      </a: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112 </a:t>
                      </a: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3395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0A0G2JDV3</a:t>
                      </a: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Gbp6</a:t>
                      </a: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Guanylate-binding protein 6</a:t>
                      </a: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363 </a:t>
                      </a: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742 </a:t>
                      </a: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3395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42225</a:t>
                      </a: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Stat1</a:t>
                      </a: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Signal transducer and activator of transcription 1</a:t>
                      </a: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044 </a:t>
                      </a: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486 </a:t>
                      </a: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3395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01887</a:t>
                      </a: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B2m</a:t>
                      </a: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l-G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β</a:t>
                      </a:r>
                      <a:r>
                        <a:rPr lang="el-G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-2-</a:t>
                      </a:r>
                      <a:r>
                        <a:rPr lang="en-GB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microglobulin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935 </a:t>
                      </a: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691 </a:t>
                      </a: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3395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Q80YX1</a:t>
                      </a: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Tnc </a:t>
                      </a: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Tenascin </a:t>
                      </a: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829 </a:t>
                      </a: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308 </a:t>
                      </a: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3395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Q9Z0E6</a:t>
                      </a: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Gbp2</a:t>
                      </a: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Guanylate-binding protein 2 </a:t>
                      </a: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801 </a:t>
                      </a: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495 </a:t>
                      </a: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3395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Q62009</a:t>
                      </a: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ostn</a:t>
                      </a: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eriostin</a:t>
                      </a: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630 </a:t>
                      </a: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6.967 </a:t>
                      </a: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3395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Q91X72</a:t>
                      </a: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Hpx</a:t>
                      </a: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Hemopexin</a:t>
                      </a: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626 </a:t>
                      </a: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8.547 </a:t>
                      </a: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3395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2A6Q8</a:t>
                      </a: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Myl4</a:t>
                      </a: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Myosin light chain 4</a:t>
                      </a: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619 </a:t>
                      </a: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6.254 </a:t>
                      </a: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3395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0A0R4J038</a:t>
                      </a: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Kng1</a:t>
                      </a: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Kininogen-1 </a:t>
                      </a: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552 </a:t>
                      </a: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5.463 </a:t>
                      </a: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3395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Q05186</a:t>
                      </a: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Rcn1</a:t>
                      </a: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Reticulocalbin-1</a:t>
                      </a: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540 </a:t>
                      </a: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630 </a:t>
                      </a: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3395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Q9CQI6</a:t>
                      </a: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Cotl1</a:t>
                      </a: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Coactosin-like protein</a:t>
                      </a: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531 </a:t>
                      </a: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983 </a:t>
                      </a: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3395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H3BK65</a:t>
                      </a: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Eps15</a:t>
                      </a: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Epidermal growth factor receptor substrate 15</a:t>
                      </a: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527 </a:t>
                      </a: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317 </a:t>
                      </a: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3395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G3UXZ5</a:t>
                      </a: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sme1</a:t>
                      </a: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roteasome activator complex subunit 1</a:t>
                      </a: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523 </a:t>
                      </a: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324 </a:t>
                      </a: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3395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3395">
                <a:tc gridSpan="3">
                  <a:txBody>
                    <a:bodyPr/>
                    <a:lstStyle/>
                    <a:p>
                      <a:pPr algn="l" fontAlgn="ctr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Down-regulated proteins (1D)</a:t>
                      </a: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3395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Q9ESM6</a:t>
                      </a: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Gdpd2</a:t>
                      </a: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Glycerophosphoinositol</a:t>
                      </a:r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 </a:t>
                      </a:r>
                      <a:r>
                        <a:rPr lang="en-GB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inositolphosphodiesterase</a:t>
                      </a:r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 </a:t>
                      </a: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-2.646 </a:t>
                      </a: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489 </a:t>
                      </a: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3395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Q9WUZ7</a:t>
                      </a: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Sh3bgr</a:t>
                      </a: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SH3 domain-binding glutamic acid-rich protein </a:t>
                      </a: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-1.517 </a:t>
                      </a: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641 </a:t>
                      </a:r>
                    </a:p>
                  </a:txBody>
                  <a:tcPr marL="8962" marR="8962" marT="89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11740671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표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15156747"/>
              </p:ext>
            </p:extLst>
          </p:nvPr>
        </p:nvGraphicFramePr>
        <p:xfrm>
          <a:off x="471487" y="488504"/>
          <a:ext cx="5915026" cy="7903224"/>
        </p:xfrm>
        <a:graphic>
          <a:graphicData uri="http://schemas.openxmlformats.org/drawingml/2006/table">
            <a:tbl>
              <a:tblPr/>
              <a:tblGrid>
                <a:gridCol w="167210"/>
                <a:gridCol w="815144"/>
                <a:gridCol w="644950"/>
                <a:gridCol w="2615630"/>
                <a:gridCol w="836046"/>
                <a:gridCol w="836046"/>
              </a:tblGrid>
              <a:tr h="216024"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ccession No.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Gene Name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rotein Description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Fold Change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-Log</a:t>
                      </a:r>
                      <a:r>
                        <a:rPr lang="en-GB" sz="800" b="1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0</a:t>
                      </a:r>
                      <a:r>
                        <a:rPr lang="en-GB" sz="8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(</a:t>
                      </a:r>
                      <a:r>
                        <a:rPr lang="en-GB" sz="800" b="1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</a:t>
                      </a:r>
                      <a:r>
                        <a:rPr lang="en-GB" sz="8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-value</a:t>
                      </a:r>
                      <a:r>
                        <a:rPr lang="en-GB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)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</a:tr>
              <a:tr h="99207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9207">
                <a:tc gridSpan="3">
                  <a:txBody>
                    <a:bodyPr/>
                    <a:lstStyle/>
                    <a:p>
                      <a:pPr algn="l" fontAlgn="ctr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Up-regulated proteins (1W)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9207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0A1B0GQV5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Saa2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Serum amyloid A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1.653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872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9207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05366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Saa1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Serum amyloid A-1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9.512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123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9207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20918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lg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lasminogen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5.499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284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9207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Q06890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Clu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Clusterin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5.488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4.230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9207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Q61646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Hp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Haptoglobin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842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9.095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9207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27005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S100a8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rotein S100-A8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769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448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9207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E9PV24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Fga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Fibrinogen alpha chain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734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3.422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9207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34928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poc1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polipoprotein C-I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561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315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9207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H7BX99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F2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rothrombin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502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874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9207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E9PVD2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Itih4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Inter alpha-trypsin inhibitor, heavy chain 4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490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6.870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9207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Q3UER8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Fgg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Fibrinogen gamma chain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099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6.031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9207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0A0R4J1N3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poc3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polipoprotein C-III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975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656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9207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Q9ESM6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Gdpd2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Glycerophosphoinositol inositolphosphodiesterase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545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392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9207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0A087WR50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Fn1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Fibronectin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544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3.370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9207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O89053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Coro1a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Coronin-1A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156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758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9207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01029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C4b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Complement C4-B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976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577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9207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Q61599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rhgdib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Rho GDP-dissociation inhibitor 2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954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106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9207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Q9CQI6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Cotl1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Coactosin-like protein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925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277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9207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10107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xa1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nexin A1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923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5.569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9207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F7ARC5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Grin3b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Glutamate receptor ionotropic, NMDA 3B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901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660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9207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43276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Hist1h1b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Histone H1.5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900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227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9207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08226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poe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polipoprotein E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890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279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9207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Q91XL1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Lrg1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Leucine-rich HEV glycoprotein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844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321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9207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Q9D154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Serpinb1a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Leukocyte elastase inhibitor A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844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686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9207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2A6Q8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Myl4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Myosin light chain 4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836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541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9207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0A0R4J039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Hrg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Histidine-rich glycoprotein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771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094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9207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Q8BGD9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Eif4b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Eukaryotic translation initiation factor 4B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697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790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9207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29699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hsg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l-G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α</a:t>
                      </a:r>
                      <a:r>
                        <a:rPr lang="el-G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-2-</a:t>
                      </a:r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HS-glycoprotein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689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582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9207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50543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S100a11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rotein S100-A11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684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422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9207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Q61233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ls2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lastin-2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659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936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9207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Q9QVP4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Mylc2a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Myosin regulatory light chain 2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625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5.496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9207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Q9Z2X1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Hnrnpf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Heterogeneous nuclear ribonucleoprotein F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603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393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9207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Q9EQI8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Mrpl46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pt-B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9S ribosomal protein L46, mitochondrial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569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452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9207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Q8BH61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F13a1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Coagulation factor XIII A chain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567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831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9207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61014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ln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Cardiac phospholamban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562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577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9207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Q9Z315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Sart1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U4/U6.U5 tri-snRNP-associated protein 1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561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903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9207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Q8C2Q7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Hnrnph1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Heterogeneous nuclear ribonucleoprotein H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558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859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9207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09813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poa2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polipoprotein A-II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553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542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9207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Q4U4S6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Xirp2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Xin actin-binding repeat-containing protein 2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545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6.756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9207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2A997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C8a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Complement component C8 alpha chain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545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281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9207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Q9CY16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Mrps28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pt-B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8S ribosomal protein S28, mitochondrial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539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003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9207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E9QQ93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Xirp1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Xin actin-binding repeat-containing protein 1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529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4.955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9207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11352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Gpx1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Glutathione peroxidase 1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522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355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9207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Q61033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Lap2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Lamina-associated polypeptide 2, isoforms alpha/zeta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515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388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9207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Q7TNC4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Luc7l2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utative RNA-binding protein Luc7-like 2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510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394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9207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9207">
                <a:tc gridSpan="3">
                  <a:txBody>
                    <a:bodyPr/>
                    <a:lstStyle/>
                    <a:p>
                      <a:pPr algn="l" fontAlgn="ctr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Down-regulated proteins (1W)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9207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0A1B0GT92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Gys1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Glycogen synthase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-2.033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417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9207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D3YVP5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Gstm7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Glutathione S-transferase Mu 7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-1.923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151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9207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Q9QUK9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trypsinogen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MCG15083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-1.842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667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1439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Q80XN0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Bdh1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l-G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β</a:t>
                      </a:r>
                      <a:r>
                        <a:rPr lang="el-G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-</a:t>
                      </a:r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hydroxybutyrate dehydrogenase, mitochondrial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-1.783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607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9207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F8WIR1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Ctsd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Cathepsin D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-1.639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014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9207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0A075B5P2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Igkc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Immunoglobulin kappa constant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-1.595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761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9207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D3Z7X0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cad12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cyl-Coenzyme A dehydrogenase family, member 12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-1.572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897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9207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F7A8H6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Gpx4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Glutathione peroxidase 4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-1.555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986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9207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54071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Idh2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Isocitrate dehydrogenase [NADP], mitochondrial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-1.536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5.955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9207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0A1B0GT63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Tmem143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Transmembrane protein 143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-1.524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713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9207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15626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Gstm2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Glutathione S-transferase Mu 2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-1.504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6.338 </a:t>
                      </a:r>
                    </a:p>
                  </a:txBody>
                  <a:tcPr marL="6200" marR="6200" marT="6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4365105" y="0"/>
            <a:ext cx="2504306" cy="3002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351" b="1" dirty="0" smtClean="0">
                <a:latin typeface="Arial" panose="020B0604020202020204" pitchFamily="34" charset="0"/>
                <a:cs typeface="Arial" panose="020B0604020202020204" pitchFamily="34" charset="0"/>
              </a:rPr>
              <a:t> Supplementary Table 3</a:t>
            </a:r>
            <a:endParaRPr lang="ko-KR" altLang="en-US" sz="135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2014555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표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51404528"/>
              </p:ext>
            </p:extLst>
          </p:nvPr>
        </p:nvGraphicFramePr>
        <p:xfrm>
          <a:off x="485555" y="416496"/>
          <a:ext cx="5915025" cy="8875892"/>
        </p:xfrm>
        <a:graphic>
          <a:graphicData uri="http://schemas.openxmlformats.org/drawingml/2006/table">
            <a:tbl>
              <a:tblPr/>
              <a:tblGrid>
                <a:gridCol w="167209"/>
                <a:gridCol w="815144"/>
                <a:gridCol w="644950"/>
                <a:gridCol w="2615630"/>
                <a:gridCol w="836046"/>
                <a:gridCol w="836046"/>
              </a:tblGrid>
              <a:tr h="216024"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ccession No.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Gene Name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rotein Description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Fold Change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-Log</a:t>
                      </a:r>
                      <a:r>
                        <a:rPr lang="en-GB" sz="800" b="1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0</a:t>
                      </a:r>
                      <a:r>
                        <a:rPr lang="en-GB" sz="8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(</a:t>
                      </a:r>
                      <a:r>
                        <a:rPr lang="en-GB" sz="800" b="1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</a:t>
                      </a:r>
                      <a:r>
                        <a:rPr lang="en-GB" sz="8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-value</a:t>
                      </a:r>
                      <a:r>
                        <a:rPr lang="en-GB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)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</a:tr>
              <a:tr h="86893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6893">
                <a:tc gridSpan="3">
                  <a:txBody>
                    <a:bodyPr/>
                    <a:lstStyle/>
                    <a:p>
                      <a:pPr algn="l" fontAlgn="ctr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Up-regulated proteins (8W)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6893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Q9JIF9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Myot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Myotilin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376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5.632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6893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Q80XN0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Bdh1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D-</a:t>
                      </a:r>
                      <a:r>
                        <a:rPr lang="el-GR" sz="8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β</a:t>
                      </a:r>
                      <a:r>
                        <a:rPr lang="el-G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-</a:t>
                      </a:r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hydroxybutyrate dehydrogenase, mitochondrial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687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527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6893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6893">
                <a:tc gridSpan="3">
                  <a:txBody>
                    <a:bodyPr/>
                    <a:lstStyle/>
                    <a:p>
                      <a:pPr algn="l" fontAlgn="ctr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Down-regulated proteins (8W)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6893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Q80YX1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Tnc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Tenascin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-8.547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416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6893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0A087WR50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Fn1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Fibronectin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-4.098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5.654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6893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Q91XV3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Basp1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Brain acid soluble protein 1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-3.425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103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6893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50543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S100a11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rotein S100-A11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-2.717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899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6893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Q3TCU5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Tapbp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Tapasin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-2.370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519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6893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19324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Serpinh1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Serpin H1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-2.299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880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6893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Q61233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ls2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lastin-2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-2.252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5.106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6893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Q6IRU2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Tpm4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Tropomyosin alpha-4 chain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-2.242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1.749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6893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E9PWT4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H2-Q7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H-2 class I histocompatibility antigen, Q7 alpha chain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-2.232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263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6893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42225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Stat1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Signal transducer and activator of transcription 1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-2.212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480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6893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Q05186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Rcn1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Reticulocalbin-1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-2.212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162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6893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Q99LB4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Capg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Capping protein (Actin filament), gelsolin-like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-2.146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619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6893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Q9WVA4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Tagln2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Transgelin-2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-2.132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311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6893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Q61646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Hp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Haptoglobin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-2.096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900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6893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01899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H2-D1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H-2 class I histocompatibility antigen, D-B alpha chain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-2.070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098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6893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0A0R4J0Z1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dia4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rotein disulfide-isomerase A4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-2.028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5.847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6893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01887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B2m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Beta-2-microglobulin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-2.008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275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6893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Q01149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Col1a2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Collagen alpha-2(I) chain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-2.000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9.507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6893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Q6P5H2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es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estin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-1.992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6.149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6893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Q8C845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Efhd2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EF-hand domain-containing protein D2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-1.976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528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6893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11087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Col1a1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Collagen alpha-1(I) chain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-1.972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6.694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6893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Q91X72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Hpx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Hemopexin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-1.938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5.991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6893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24369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pib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eptidyl-prolyl cis-trans isomerase B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-1.919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5.267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6893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26350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tma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rothymosin alph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-1.912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672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6893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O89053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Coro1a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Coronin-1A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-1.908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808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6893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Q3TML0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dia6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rotein disulfide-isomerase A6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-1.883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6.468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6893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Q8BMK4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Ckap4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Cytoskeleton-associated protein 4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-1.876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9.711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6893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43276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Hist1h1b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Histone H1.5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-1.869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916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6893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0A0R4J1N3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poc3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polipoprotein C-III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-1.832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356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6893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14211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Calr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Calreticulin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-1.821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9.605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6893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0A1C7CYV0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ls3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lastin-3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-1.805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532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6893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Q99P72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Rtn4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Reticulon-4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-1.799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967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6893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0A0G2JDV3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Gbp6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Guanylate-binding protein 6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-1.799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889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6893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Q99K41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Emilin1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EMILIN-1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-1.795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016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6893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Q61937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pm1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ucleophosmin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-1.764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848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6893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27773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dia3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rotein disulfide-isomerase A3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-1.754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1.398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6893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Q9D0J8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tms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arathymosin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-1.745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486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6893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26645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Marcks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Myristoylated alanine-rich C-kinase substrate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-1.733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535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6893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2BE93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Set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rotein SET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-1.733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229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6893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Q8BHN3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Ganab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eutral alpha-glucosidase AB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-1.727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156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6893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03995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Gfap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Glial fibrillary acidic protein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-1.718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930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6893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Q8CFQ9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Fus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Fusion, derived from t(1216) malignant liposarcoma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-1.712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934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6893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F6TVP2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Samhd1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Deoxynucleoside triphosphate triphosphohydrolase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-1.704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687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6893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E9PWE8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Dpysl3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Dihydropyrimidinase-related protein 3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-1.692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645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6893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Q8BFW7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Lpp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Lipoma-preferred partner homolog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-1.684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207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6893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Q61554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Fbn1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Fibrillin-1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-1.672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576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6893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O35887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Calu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Calumenin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-1.672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483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6893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Q5M8M8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Rpl29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60S ribosomal protein L29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-1.664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148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6893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Q8VIJ6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Sfpq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Splicing factor, proline- and glutamine-rich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-1.661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7.811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6893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Q9DCC5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Cbx3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Cbx3 protein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-1.658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057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6893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Q00915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Rbp1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Retinol-binding protein 1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-1.642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378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6893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G3UXZ5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sme1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roteasome activator complex subunit 1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-1.639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897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6893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Q9Z0E6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Gbp2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Guanylate-binding protein 2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-1.637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307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6893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Q9JKF1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Iqgap1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Ras GTPase-activating-like protein IQGAP1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-1.637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304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6893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14148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Rpl7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60S ribosomal protein L7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-1.631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796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6893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Q9ERG0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Lima1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LIM domain and actin-binding protein 1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-1.623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310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6893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29341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abpc1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olyadenylate-binding protein 1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-1.623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.823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6893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28653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Bgn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Biglycan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-1.621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097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6893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0A087WP83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Hdlbp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Vigilin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-1.608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5.901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6893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18760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Cfl1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Cofilin-1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-1.603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.512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6893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Q921L6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Cttn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Cortactin, isoform CRA_a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-1.603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.857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6893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Q99020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Hnrnpab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Heterogeneous nuclear ribonucleoprotein A/B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-1.600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.290 </a:t>
                      </a:r>
                    </a:p>
                  </a:txBody>
                  <a:tcPr marL="5431" marR="5431" marT="54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  <p:sp>
        <p:nvSpPr>
          <p:cNvPr id="9" name="TextBox 8"/>
          <p:cNvSpPr txBox="1"/>
          <p:nvPr/>
        </p:nvSpPr>
        <p:spPr>
          <a:xfrm>
            <a:off x="4365105" y="0"/>
            <a:ext cx="2504306" cy="3002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351" b="1" dirty="0" smtClean="0">
                <a:latin typeface="Arial" panose="020B0604020202020204" pitchFamily="34" charset="0"/>
                <a:cs typeface="Arial" panose="020B0604020202020204" pitchFamily="34" charset="0"/>
              </a:rPr>
              <a:t> Supplementary Table 4</a:t>
            </a:r>
            <a:endParaRPr lang="ko-KR" altLang="en-US" sz="135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7417880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22</TotalTime>
  <Words>1122</Words>
  <Application>Microsoft Office PowerPoint</Application>
  <PresentationFormat>A4 용지(210x297mm)</PresentationFormat>
  <Paragraphs>715</Paragraphs>
  <Slides>3</Slides>
  <Notes>3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3</vt:i4>
      </vt:variant>
    </vt:vector>
  </HeadingPairs>
  <TitlesOfParts>
    <vt:vector size="8" baseType="lpstr">
      <vt:lpstr>맑은 고딕</vt:lpstr>
      <vt:lpstr>Arial</vt:lpstr>
      <vt:lpstr>Calibri</vt:lpstr>
      <vt:lpstr>Calibri Light</vt:lpstr>
      <vt:lpstr>Office 테마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user</cp:lastModifiedBy>
  <cp:revision>18</cp:revision>
  <dcterms:created xsi:type="dcterms:W3CDTF">2018-12-10T02:20:57Z</dcterms:created>
  <dcterms:modified xsi:type="dcterms:W3CDTF">2019-08-01T08:09:10Z</dcterms:modified>
</cp:coreProperties>
</file>